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Default Extension="emf" ContentType="image/x-emf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0" r:id="rId3"/>
    <p:sldId id="262" r:id="rId4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30" autoAdjust="0"/>
    <p:restoredTop sz="94660" autoAdjust="0"/>
  </p:normalViewPr>
  <p:slideViewPr>
    <p:cSldViewPr snapToGrid="0">
      <p:cViewPr>
        <p:scale>
          <a:sx n="156" d="100"/>
          <a:sy n="156" d="100"/>
        </p:scale>
        <p:origin x="448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2.xml"/><Relationship Id="rId5" Type="http://schemas.openxmlformats.org/officeDocument/2006/relationships/printerSettings" Target="printerSettings/printerSettings1.bin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35342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43955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71403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19987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17054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431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79992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45763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86660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194678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90137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CE9E1-7408-45B0-966F-E86036ABA436}" type="datetimeFigureOut">
              <a:rPr lang="en-IE" smtClean="0"/>
              <a:t>06/07/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D40292-8853-4AEA-9E62-B16EA3C18A5B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89572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0425145"/>
              </p:ext>
            </p:extLst>
          </p:nvPr>
        </p:nvGraphicFramePr>
        <p:xfrm>
          <a:off x="1097109" y="2928927"/>
          <a:ext cx="3827322" cy="1369745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358531"/>
                <a:gridCol w="2468791"/>
              </a:tblGrid>
              <a:tr h="273949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Q-PCR Target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Sequence 5’ – 3’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3949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CD274_f  (PD-L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GATCCATCCTGTTGTTCCTCAT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3949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CD274_r (PD-L1)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CGCCACATTTCTCCACATCTA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3949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PKM2_f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GCTATTCGAGGAACTCCGCC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73949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PKM2_r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AAGGTACAGGCACTACACGC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105374" y="2643866"/>
            <a:ext cx="16070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Table </a:t>
            </a:r>
            <a:r>
              <a:rPr lang="en-US" sz="1200" dirty="0" smtClean="0">
                <a:latin typeface="Times New Roman"/>
                <a:cs typeface="Times New Roman"/>
              </a:rPr>
              <a:t>2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05374" y="4504470"/>
            <a:ext cx="1608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Table </a:t>
            </a:r>
            <a:r>
              <a:rPr lang="en-US" sz="1200" dirty="0" smtClean="0">
                <a:latin typeface="Times New Roman"/>
                <a:cs typeface="Times New Roman"/>
              </a:rPr>
              <a:t>3</a:t>
            </a:r>
            <a:endParaRPr lang="en-US" sz="1200" dirty="0">
              <a:latin typeface="Times New Roman"/>
              <a:cs typeface="Times New Roman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1373520"/>
              </p:ext>
            </p:extLst>
          </p:nvPr>
        </p:nvGraphicFramePr>
        <p:xfrm>
          <a:off x="1127442" y="4868512"/>
          <a:ext cx="4525193" cy="137160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665112"/>
                <a:gridCol w="3860081"/>
              </a:tblGrid>
              <a:tr h="280007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Biotin – OPD site 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Sequence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42228">
                <a:tc>
                  <a:txBody>
                    <a:bodyPr/>
                    <a:lstStyle/>
                    <a:p>
                      <a:r>
                        <a:rPr lang="en-US" sz="1000" kern="1200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HRE1</a:t>
                      </a:r>
                      <a:r>
                        <a:rPr lang="en-IE" sz="1000" dirty="0" smtClean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kern="1200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’BIO-ATAAAGCTTGGCCAGGCGTGGTGGCGCACACCTT-3’</a:t>
                      </a:r>
                      <a:r>
                        <a:rPr lang="en-IE" sz="1000" dirty="0" smtClean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42228">
                <a:tc>
                  <a:txBody>
                    <a:bodyPr/>
                    <a:lstStyle/>
                    <a:p>
                      <a:endParaRPr lang="en-US" sz="100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kern="1200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’-AAGGTGTGCGCCACCACGCCTGGCCAAGCTTTAT-3’</a:t>
                      </a:r>
                      <a:r>
                        <a:rPr lang="en-IE" sz="1000" dirty="0" smtClean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42228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/>
                          <a:cs typeface="Times New Roman"/>
                        </a:rPr>
                        <a:t>HRE4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kern="1200" cap="all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’BIO-GGCTGCACTTGcacgtcgcgGGCCAGTCTCCTCG-3’</a:t>
                      </a:r>
                      <a:r>
                        <a:rPr lang="en-IE" sz="1000" dirty="0" smtClean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  <a:tr h="242228">
                <a:tc>
                  <a:txBody>
                    <a:bodyPr/>
                    <a:lstStyle/>
                    <a:p>
                      <a:endParaRPr lang="en-US" sz="100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kern="1200" cap="all" dirty="0" smtClean="0">
                          <a:solidFill>
                            <a:schemeClr val="dk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’-CGAGGAGACTGGCCCGCGACGTGCAAGTGCAGCC-3’</a:t>
                      </a:r>
                      <a:r>
                        <a:rPr lang="en-IE" sz="1000" dirty="0" smtClean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6401449"/>
              </p:ext>
            </p:extLst>
          </p:nvPr>
        </p:nvGraphicFramePr>
        <p:xfrm>
          <a:off x="1072512" y="800510"/>
          <a:ext cx="4040455" cy="1577368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843459"/>
                <a:gridCol w="1176769"/>
                <a:gridCol w="569745"/>
                <a:gridCol w="1450482"/>
              </a:tblGrid>
              <a:tr h="257286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 dirty="0">
                          <a:effectLst/>
                          <a:latin typeface="Times New Roman"/>
                          <a:cs typeface="Times New Roman"/>
                        </a:rPr>
                        <a:t>Specificity</a:t>
                      </a:r>
                      <a:endParaRPr lang="en-IE" sz="100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 dirty="0">
                          <a:effectLst/>
                          <a:latin typeface="Times New Roman"/>
                          <a:cs typeface="Times New Roman"/>
                        </a:rPr>
                        <a:t>Fluorochrome</a:t>
                      </a:r>
                      <a:endParaRPr lang="en-IE" sz="100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Clone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Supplier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1444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CD19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PE-CF954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1D3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 dirty="0">
                          <a:effectLst/>
                          <a:latin typeface="Times New Roman"/>
                          <a:cs typeface="Times New Roman"/>
                        </a:rPr>
                        <a:t>BD Biosciences</a:t>
                      </a:r>
                      <a:endParaRPr lang="en-IE" sz="100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1444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CD3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BV650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17A2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eBioscience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47867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CD11b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APC-eFluor 780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M1/70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eBioscience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1444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CD11c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 dirty="0">
                          <a:effectLst/>
                          <a:latin typeface="Times New Roman"/>
                          <a:cs typeface="Times New Roman"/>
                        </a:rPr>
                        <a:t>BV605</a:t>
                      </a:r>
                      <a:endParaRPr lang="en-IE" sz="100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N418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eBioscience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1444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CD45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BV711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30-F11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BioLegend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1444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>
                          <a:effectLst/>
                          <a:latin typeface="Times New Roman"/>
                          <a:cs typeface="Times New Roman"/>
                        </a:rPr>
                        <a:t>F4/80</a:t>
                      </a:r>
                      <a:endParaRPr lang="en-IE" sz="100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 dirty="0">
                          <a:effectLst/>
                          <a:latin typeface="Times New Roman"/>
                          <a:cs typeface="Times New Roman"/>
                        </a:rPr>
                        <a:t>PE-Cy7</a:t>
                      </a:r>
                      <a:endParaRPr lang="en-IE" sz="100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 dirty="0">
                          <a:effectLst/>
                          <a:latin typeface="Times New Roman"/>
                          <a:cs typeface="Times New Roman"/>
                        </a:rPr>
                        <a:t>BM8</a:t>
                      </a:r>
                      <a:endParaRPr lang="en-IE" sz="100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IE" sz="1000" dirty="0">
                          <a:effectLst/>
                          <a:latin typeface="Times New Roman"/>
                          <a:cs typeface="Times New Roman"/>
                        </a:rPr>
                        <a:t>BioLegend</a:t>
                      </a:r>
                      <a:endParaRPr lang="en-IE" sz="1000" dirty="0">
                        <a:effectLst/>
                        <a:latin typeface="Times New Roman"/>
                        <a:ea typeface="Calibri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105374" y="470493"/>
            <a:ext cx="16070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Table </a:t>
            </a:r>
            <a:r>
              <a:rPr lang="en-US" sz="1200" dirty="0" smtClean="0">
                <a:latin typeface="Times New Roman"/>
                <a:cs typeface="Times New Roman"/>
              </a:rPr>
              <a:t>1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14878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92819" y="989421"/>
            <a:ext cx="5560097" cy="5415208"/>
            <a:chOff x="0" y="3169385"/>
            <a:chExt cx="5560097" cy="5415208"/>
          </a:xfrm>
        </p:grpSpPr>
        <p:sp>
          <p:nvSpPr>
            <p:cNvPr id="10" name="TextBox 9"/>
            <p:cNvSpPr txBox="1"/>
            <p:nvPr/>
          </p:nvSpPr>
          <p:spPr>
            <a:xfrm>
              <a:off x="0" y="3169385"/>
              <a:ext cx="31983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200" dirty="0" smtClean="0">
                  <a:latin typeface="Times New Roman"/>
                  <a:cs typeface="Times New Roman"/>
                </a:rPr>
                <a:t>Supplementary </a:t>
              </a:r>
              <a:r>
                <a:rPr lang="en-IE" sz="1200" dirty="0">
                  <a:latin typeface="Times New Roman"/>
                  <a:cs typeface="Times New Roman"/>
                </a:rPr>
                <a:t>F</a:t>
              </a:r>
              <a:r>
                <a:rPr lang="en-IE" sz="1200" dirty="0" smtClean="0">
                  <a:latin typeface="Times New Roman"/>
                  <a:cs typeface="Times New Roman"/>
                </a:rPr>
                <a:t>igure 1. </a:t>
              </a:r>
              <a:r>
                <a:rPr lang="en-IE" sz="1200" dirty="0">
                  <a:latin typeface="Times New Roman"/>
                  <a:cs typeface="Times New Roman"/>
                </a:rPr>
                <a:t>Tumour gating strategy </a:t>
              </a:r>
            </a:p>
          </p:txBody>
        </p:sp>
        <p:grpSp>
          <p:nvGrpSpPr>
            <p:cNvPr id="46" name="Group 45"/>
            <p:cNvGrpSpPr/>
            <p:nvPr/>
          </p:nvGrpSpPr>
          <p:grpSpPr>
            <a:xfrm>
              <a:off x="550649" y="3491456"/>
              <a:ext cx="5009448" cy="5093137"/>
              <a:chOff x="550649" y="3491456"/>
              <a:chExt cx="5009448" cy="5093137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00101" y="3491456"/>
                <a:ext cx="4702070" cy="4813421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1150620" y="4840196"/>
                <a:ext cx="7232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344910" y="4024856"/>
                <a:ext cx="7344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827020" y="4847816"/>
                <a:ext cx="7232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2022113" y="4032476"/>
                <a:ext cx="73289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H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511040" y="4847816"/>
                <a:ext cx="7232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6200000">
                <a:off x="3592320" y="4032476"/>
                <a:ext cx="96051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ive/dead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143000" y="6554696"/>
                <a:ext cx="6431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337290" y="5739356"/>
                <a:ext cx="7344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819400" y="6554696"/>
                <a:ext cx="5437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6200000">
                <a:off x="2059376" y="5739356"/>
                <a:ext cx="6431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495800" y="6547076"/>
                <a:ext cx="5437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3692752" y="5731736"/>
                <a:ext cx="72917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1143000" y="8276816"/>
                <a:ext cx="64152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6200000">
                <a:off x="339952" y="7461476"/>
                <a:ext cx="72917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819400" y="8276816"/>
                <a:ext cx="64152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6200000">
                <a:off x="2021161" y="7461476"/>
                <a:ext cx="71955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c</a:t>
                </a:r>
              </a:p>
            </p:txBody>
          </p:sp>
          <p:cxnSp>
            <p:nvCxnSpPr>
              <p:cNvPr id="28" name="Straight Arrow Connector 27"/>
              <p:cNvCxnSpPr/>
              <p:nvPr/>
            </p:nvCxnSpPr>
            <p:spPr>
              <a:xfrm>
                <a:off x="2227050" y="4666624"/>
                <a:ext cx="315398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Arrow Connector 28"/>
              <p:cNvCxnSpPr/>
              <p:nvPr/>
            </p:nvCxnSpPr>
            <p:spPr>
              <a:xfrm>
                <a:off x="3865350" y="4674244"/>
                <a:ext cx="315398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Arrow Connector 29"/>
              <p:cNvCxnSpPr/>
              <p:nvPr/>
            </p:nvCxnSpPr>
            <p:spPr>
              <a:xfrm flipH="1">
                <a:off x="2082297" y="5140353"/>
                <a:ext cx="2228082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V="1">
                <a:off x="4310379" y="4939256"/>
                <a:ext cx="0" cy="201097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V="1">
                <a:off x="2082297" y="5140353"/>
                <a:ext cx="0" cy="201097"/>
              </a:xfrm>
              <a:prstGeom prst="line">
                <a:avLst/>
              </a:prstGeom>
              <a:ln w="38100">
                <a:solidFill>
                  <a:schemeClr val="tx1"/>
                </a:solidFill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/>
              <p:cNvCxnSpPr/>
              <p:nvPr/>
            </p:nvCxnSpPr>
            <p:spPr>
              <a:xfrm>
                <a:off x="2211810" y="6289684"/>
                <a:ext cx="315398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Rectangle 33"/>
              <p:cNvSpPr/>
              <p:nvPr/>
            </p:nvSpPr>
            <p:spPr>
              <a:xfrm>
                <a:off x="2572929" y="5363664"/>
                <a:ext cx="528411" cy="59667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E" dirty="0"/>
              </a:p>
            </p:txBody>
          </p:sp>
          <p:cxnSp>
            <p:nvCxnSpPr>
              <p:cNvPr id="35" name="Straight Arrow Connector 34"/>
              <p:cNvCxnSpPr/>
              <p:nvPr/>
            </p:nvCxnSpPr>
            <p:spPr>
              <a:xfrm flipV="1">
                <a:off x="3603293" y="6214807"/>
                <a:ext cx="1037287" cy="168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Rectangle 35"/>
              <p:cNvSpPr/>
              <p:nvPr/>
            </p:nvSpPr>
            <p:spPr>
              <a:xfrm>
                <a:off x="4668079" y="6122709"/>
                <a:ext cx="611616" cy="21845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E" dirty="0"/>
              </a:p>
            </p:txBody>
          </p:sp>
          <p:cxnSp>
            <p:nvCxnSpPr>
              <p:cNvPr id="37" name="Straight Arrow Connector 36"/>
              <p:cNvCxnSpPr/>
              <p:nvPr/>
            </p:nvCxnSpPr>
            <p:spPr>
              <a:xfrm flipH="1">
                <a:off x="1981200" y="6474684"/>
                <a:ext cx="766202" cy="460512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/>
              <p:cNvCxnSpPr/>
              <p:nvPr/>
            </p:nvCxnSpPr>
            <p:spPr>
              <a:xfrm>
                <a:off x="2759224" y="6474684"/>
                <a:ext cx="77910" cy="48406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Rectangle 38"/>
              <p:cNvSpPr/>
              <p:nvPr/>
            </p:nvSpPr>
            <p:spPr>
              <a:xfrm>
                <a:off x="1374913" y="7376822"/>
                <a:ext cx="691200" cy="52631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E" dirty="0"/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2724705" y="7207959"/>
                <a:ext cx="270286" cy="450000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E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3263149" y="5202947"/>
                <a:ext cx="63511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226469" y="5197431"/>
                <a:ext cx="133362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526180" y="6938740"/>
                <a:ext cx="139333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1c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069829" y="6927854"/>
                <a:ext cx="117327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pPr algn="r"/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IE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  <a:r>
                  <a:rPr lang="en-IE" sz="12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042281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404" y="1601798"/>
            <a:ext cx="2826949" cy="244749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98046" y="483383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Figure 2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473654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350D933D1F0B94BBAB0BD440E363FC8" ma:contentTypeVersion="7" ma:contentTypeDescription="Create a new document." ma:contentTypeScope="" ma:versionID="9b91d12c69b0b06fb5fc5553a5ae3899">
  <xsd:schema xmlns:xsd="http://www.w3.org/2001/XMLSchema" xmlns:p="http://schemas.microsoft.com/office/2006/metadata/properties" xmlns:ns2="d3c69c58-74ff-44a8-9788-42871589f19e" targetNamespace="http://schemas.microsoft.com/office/2006/metadata/properties" ma:root="true" ma:fieldsID="019318177470c37874020093bc95e111" ns2:_="">
    <xsd:import namespace="d3c69c58-74ff-44a8-9788-42871589f19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3c69c58-74ff-44a8-9788-42871589f19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d3c69c58-74ff-44a8-9788-42871589f19e" xsi:nil="true"/>
    <DocumentId xmlns="d3c69c58-74ff-44a8-9788-42871589f19e">Presentation 1.PPTX</DocumentId>
    <DocumentType xmlns="d3c69c58-74ff-44a8-9788-42871589f19e">Presentation</DocumentType>
    <FileFormat xmlns="d3c69c58-74ff-44a8-9788-42871589f19e">PPTX</FileFormat>
    <Checked_x0020_Out_x0020_To xmlns="d3c69c58-74ff-44a8-9788-42871589f19e">
      <UserInfo>
        <DisplayName/>
        <AccountId xsi:nil="true"/>
        <AccountType/>
      </UserInfo>
    </Checked_x0020_Out_x0020_To>
    <TitleName xmlns="d3c69c58-74ff-44a8-9788-42871589f19e">Presentation 1.PPTX</TitleName>
    <IsDeleted xmlns="d3c69c58-74ff-44a8-9788-42871589f19e">false</IsDeleted>
  </documentManagement>
</p:properties>
</file>

<file path=customXml/itemProps1.xml><?xml version="1.0" encoding="utf-8"?>
<ds:datastoreItem xmlns:ds="http://schemas.openxmlformats.org/officeDocument/2006/customXml" ds:itemID="{3B6BDBEB-00ED-42B4-A9A8-BD563C780B0C}"/>
</file>

<file path=customXml/itemProps2.xml><?xml version="1.0" encoding="utf-8"?>
<ds:datastoreItem xmlns:ds="http://schemas.openxmlformats.org/officeDocument/2006/customXml" ds:itemID="{C9498B6E-32FC-4252-8DFA-123833F70D57}"/>
</file>

<file path=customXml/itemProps3.xml><?xml version="1.0" encoding="utf-8"?>
<ds:datastoreItem xmlns:ds="http://schemas.openxmlformats.org/officeDocument/2006/customXml" ds:itemID="{DAA08507-EBE6-40DA-A754-3BAF004B2A30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02</TotalTime>
  <Words>190</Words>
  <Application>Microsoft Macintosh PowerPoint</Application>
  <PresentationFormat>On-screen Show (4:3)</PresentationFormat>
  <Paragraphs>7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dia Dyck</dc:creator>
  <cp:lastModifiedBy>Eva</cp:lastModifiedBy>
  <cp:revision>32</cp:revision>
  <cp:lastPrinted>2017-06-16T14:34:24Z</cp:lastPrinted>
  <dcterms:created xsi:type="dcterms:W3CDTF">2017-05-12T10:26:27Z</dcterms:created>
  <dcterms:modified xsi:type="dcterms:W3CDTF">2017-07-07T12:17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350D933D1F0B94BBAB0BD440E363FC8</vt:lpwstr>
  </property>
</Properties>
</file>